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png" ContentType="image/png"/>
  <Override PartName="/ppt/media/image10.wmf" ContentType="image/x-wmf"/>
  <Override PartName="/ppt/media/image7.png" ContentType="image/png"/>
  <Override PartName="/ppt/media/image8.png" ContentType="image/png"/>
  <Override PartName="/ppt/media/image9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4825" cy="97123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8D645-1D36-4367-8FCF-24E6E2496C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F1992-3523-43BA-8C11-3C907F5DE7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10DDD-0076-483B-B3AE-F477FD0AC4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68345-4E7F-45B0-BFE8-F092753670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D46E7-0FEB-43B9-A54B-6FB28831AD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A068F-0AF5-4E0E-9B28-643945AEF6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4DD8C7-C46B-4122-8E7A-6EFA667D72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B8EEFC-6895-4693-A23E-2421D74106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F8952-E900-4D9A-90F3-3AA320A862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25F78-033B-4080-8E41-C5033506BF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424E8-125B-4DDD-B28A-5671D4C75B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2F159-3852-4CB9-931C-3CE5993D9B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57DDEC-2CED-4844-98DD-F7FE1A6DEC6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oleObject" Target="../embeddings/oleObject1.bin"/><Relationship Id="rId6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8" Type="http://schemas.openxmlformats.org/officeDocument/2006/relationships/image" Target="../media/image6.png"/><Relationship Id="rId9" Type="http://schemas.openxmlformats.org/officeDocument/2006/relationships/oleObject" Target="../embeddings/oleObject3.bin"/><Relationship Id="rId10" Type="http://schemas.openxmlformats.org/officeDocument/2006/relationships/image" Target="../media/image7.png"/><Relationship Id="rId11" Type="http://schemas.openxmlformats.org/officeDocument/2006/relationships/oleObject" Target="../embeddings/oleObject4.bin"/><Relationship Id="rId12" Type="http://schemas.openxmlformats.org/officeDocument/2006/relationships/image" Target="../media/image8.png"/><Relationship Id="rId13" Type="http://schemas.openxmlformats.org/officeDocument/2006/relationships/package" Target="../embeddings/oleObject5.xlsx"/><Relationship Id="rId14" Type="http://schemas.openxmlformats.org/officeDocument/2006/relationships/image" Target="../media/image9.wmf"/><Relationship Id="rId15" Type="http://schemas.openxmlformats.org/officeDocument/2006/relationships/package" Target="../embeddings/oleObject6.xlsx"/><Relationship Id="rId16" Type="http://schemas.openxmlformats.org/officeDocument/2006/relationships/image" Target="../media/image10.wmf"/><Relationship Id="rId1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95280" y="284040"/>
            <a:ext cx="4530960" cy="6386760"/>
            <a:chOff x="395280" y="284040"/>
            <a:chExt cx="4530960" cy="638676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898200" y="603360"/>
              <a:ext cx="1729080" cy="129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2698560" y="1989000"/>
              <a:ext cx="1728720" cy="129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tretch/>
          </p:blipFill>
          <p:spPr>
            <a:xfrm>
              <a:off x="2698560" y="603360"/>
              <a:ext cx="1728720" cy="129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395280" y="3083040"/>
              <a:ext cx="52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65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66920" y="1700280"/>
              <a:ext cx="42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a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053080" y="284040"/>
              <a:ext cx="1536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PC-3 </a:t>
              </a: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(PDGFR</a:t>
              </a:r>
              <a:r>
                <a:rPr b="1" lang="es-ES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354560" y="3068640"/>
              <a:ext cx="52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1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355280" y="1641600"/>
              <a:ext cx="57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" descr=""/>
            <p:cNvPicPr/>
            <p:nvPr/>
          </p:nvPicPr>
          <p:blipFill>
            <a:blip r:embed="rId4"/>
            <a:stretch/>
          </p:blipFill>
          <p:spPr>
            <a:xfrm>
              <a:off x="898200" y="1989000"/>
              <a:ext cx="1727280" cy="1297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1" name=""/>
            <p:cNvGrpSpPr/>
            <p:nvPr/>
          </p:nvGrpSpPr>
          <p:grpSpPr>
            <a:xfrm>
              <a:off x="898200" y="3913200"/>
              <a:ext cx="3529080" cy="2755440"/>
              <a:chOff x="898200" y="3913200"/>
              <a:chExt cx="3529080" cy="2755440"/>
            </a:xfrm>
          </p:grpSpPr>
          <p:graphicFrame>
            <p:nvGraphicFramePr>
              <p:cNvPr id="52" name=""/>
              <p:cNvGraphicFramePr/>
              <p:nvPr/>
            </p:nvGraphicFramePr>
            <p:xfrm>
              <a:off x="898200" y="5310000"/>
              <a:ext cx="1729080" cy="135396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53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898200" y="5310000"/>
                        <a:ext cx="1729080" cy="13539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4" name=""/>
              <p:cNvGraphicFramePr/>
              <p:nvPr/>
            </p:nvGraphicFramePr>
            <p:xfrm>
              <a:off x="898200" y="3913200"/>
              <a:ext cx="1729080" cy="131112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55" name="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898200" y="3913200"/>
                        <a:ext cx="1729080" cy="13111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6" name=""/>
              <p:cNvGraphicFramePr/>
              <p:nvPr/>
            </p:nvGraphicFramePr>
            <p:xfrm>
              <a:off x="2698560" y="5295600"/>
              <a:ext cx="1728720" cy="137304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57" name="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2698560" y="5295600"/>
                        <a:ext cx="1728720" cy="1373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8" name=""/>
              <p:cNvGraphicFramePr/>
              <p:nvPr/>
            </p:nvGraphicFramePr>
            <p:xfrm>
              <a:off x="2698560" y="3927240"/>
              <a:ext cx="1728720" cy="129672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59" name="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2698560" y="3927240"/>
                        <a:ext cx="1728720" cy="1296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sp>
          <p:nvSpPr>
            <p:cNvPr id="60" name=""/>
            <p:cNvSpPr/>
            <p:nvPr/>
          </p:nvSpPr>
          <p:spPr>
            <a:xfrm>
              <a:off x="395280" y="6394320"/>
              <a:ext cx="52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65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66920" y="5011560"/>
              <a:ext cx="42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a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354560" y="6394320"/>
              <a:ext cx="52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1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355280" y="4967280"/>
              <a:ext cx="57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686600" y="3597120"/>
              <a:ext cx="2257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600" spc="-1" strike="noStrike">
                  <a:solidFill>
                    <a:srgbClr val="000000"/>
                  </a:solidFill>
                  <a:latin typeface="Arial"/>
                </a:rPr>
                <a:t>A549 </a:t>
              </a:r>
              <a:r>
                <a:rPr b="1" lang="es-ES" sz="1400" spc="-1" strike="noStrike">
                  <a:solidFill>
                    <a:srgbClr val="000000"/>
                  </a:solidFill>
                  <a:latin typeface="Arial"/>
                </a:rPr>
                <a:t>(active caspase-3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65" name=""/>
          <p:cNvGraphicFramePr/>
          <p:nvPr/>
        </p:nvGraphicFramePr>
        <p:xfrm>
          <a:off x="5508720" y="4511520"/>
          <a:ext cx="3111480" cy="2102040"/>
        </p:xfrm>
        <a:graphic>
          <a:graphicData uri="http://schemas.openxmlformats.org/presentationml/2006/ole">
            <p:oleObj progId="Excel.Sheet.12" r:id="rId13" spid="">
              <p:embed/>
              <p:pic>
                <p:nvPicPr>
                  <p:cNvPr id="66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5508720" y="4511520"/>
                    <a:ext cx="3111480" cy="2102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67" name=""/>
          <p:cNvGrpSpPr/>
          <p:nvPr/>
        </p:nvGrpSpPr>
        <p:grpSpPr>
          <a:xfrm>
            <a:off x="5796000" y="4189320"/>
            <a:ext cx="2808360" cy="337320"/>
            <a:chOff x="5796000" y="4189320"/>
            <a:chExt cx="2808360" cy="337320"/>
          </a:xfrm>
        </p:grpSpPr>
        <p:sp>
          <p:nvSpPr>
            <p:cNvPr id="68" name=""/>
            <p:cNvSpPr/>
            <p:nvPr/>
          </p:nvSpPr>
          <p:spPr>
            <a:xfrm>
              <a:off x="5796000" y="4525920"/>
              <a:ext cx="115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7523280" y="4525920"/>
              <a:ext cx="108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6013440" y="4189320"/>
              <a:ext cx="64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PC-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7742160" y="4189320"/>
              <a:ext cx="66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54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"/>
          <p:cNvSpPr/>
          <p:nvPr/>
        </p:nvSpPr>
        <p:spPr>
          <a:xfrm>
            <a:off x="6197760" y="3860640"/>
            <a:ext cx="190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CTIVE CASPASE-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3" name=""/>
          <p:cNvGraphicFramePr/>
          <p:nvPr/>
        </p:nvGraphicFramePr>
        <p:xfrm>
          <a:off x="5508720" y="1577880"/>
          <a:ext cx="3384360" cy="1851120"/>
        </p:xfrm>
        <a:graphic>
          <a:graphicData uri="http://schemas.openxmlformats.org/presentationml/2006/ole">
            <p:oleObj progId="Excel.Sheet.12" r:id="rId15" spid="">
              <p:embed/>
              <p:pic>
                <p:nvPicPr>
                  <p:cNvPr id="74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5508720" y="1577880"/>
                    <a:ext cx="3384360" cy="185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75" name=""/>
          <p:cNvGrpSpPr/>
          <p:nvPr/>
        </p:nvGrpSpPr>
        <p:grpSpPr>
          <a:xfrm>
            <a:off x="5796000" y="1268280"/>
            <a:ext cx="2808360" cy="337320"/>
            <a:chOff x="5796000" y="1268280"/>
            <a:chExt cx="2808360" cy="337320"/>
          </a:xfrm>
        </p:grpSpPr>
        <p:sp>
          <p:nvSpPr>
            <p:cNvPr id="76" name=""/>
            <p:cNvSpPr/>
            <p:nvPr/>
          </p:nvSpPr>
          <p:spPr>
            <a:xfrm>
              <a:off x="5796000" y="1604880"/>
              <a:ext cx="115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7523280" y="1604880"/>
              <a:ext cx="108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013440" y="1268280"/>
              <a:ext cx="64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PC-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742160" y="1268280"/>
              <a:ext cx="665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54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"/>
          <p:cNvSpPr/>
          <p:nvPr/>
        </p:nvSpPr>
        <p:spPr>
          <a:xfrm>
            <a:off x="6693840" y="981000"/>
            <a:ext cx="90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PDGFR</a:t>
            </a:r>
            <a:r>
              <a:rPr b="1" lang="es-ES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793920" y="115920"/>
            <a:ext cx="224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Supplementary Fig. 2 Catena et al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16200000">
            <a:off x="4967280" y="2315880"/>
            <a:ext cx="89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Area fra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16200000">
            <a:off x="4735440" y="5356080"/>
            <a:ext cx="136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N. of cells / Ref. are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443640" y="54450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012000" y="472428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5796000" y="4723920"/>
            <a:ext cx="431640" cy="143280"/>
            <a:chOff x="5796000" y="4723920"/>
            <a:chExt cx="431640" cy="143280"/>
          </a:xfrm>
        </p:grpSpPr>
        <p:sp>
          <p:nvSpPr>
            <p:cNvPr id="87" name=""/>
            <p:cNvSpPr/>
            <p:nvPr/>
          </p:nvSpPr>
          <p:spPr>
            <a:xfrm>
              <a:off x="5796000" y="486720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6011640" y="4723920"/>
              <a:ext cx="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"/>
          <p:cNvSpPr/>
          <p:nvPr/>
        </p:nvSpPr>
        <p:spPr>
          <a:xfrm flipV="1">
            <a:off x="6516720" y="4724280"/>
            <a:ext cx="0" cy="72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158160" y="45021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1T09:24:56Z</dcterms:created>
  <dc:creator>galarregui</dc:creator>
  <dc:description/>
  <dc:language>en-US</dc:language>
  <cp:lastModifiedBy>galarregui</cp:lastModifiedBy>
  <dcterms:modified xsi:type="dcterms:W3CDTF">2010-12-21T18:41:47Z</dcterms:modified>
  <cp:revision>9</cp:revision>
  <dc:subject/>
  <dc:title>Diapositiva 1</dc:title>
</cp:coreProperties>
</file>